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11"/>
  </p:notesMasterIdLst>
  <p:sldIdLst>
    <p:sldId id="266" r:id="rId5"/>
    <p:sldId id="263" r:id="rId6"/>
    <p:sldId id="258" r:id="rId7"/>
    <p:sldId id="268" r:id="rId8"/>
    <p:sldId id="267" r:id="rId9"/>
    <p:sldId id="264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84854" autoAdjust="0"/>
  </p:normalViewPr>
  <p:slideViewPr>
    <p:cSldViewPr snapToGrid="0">
      <p:cViewPr varScale="1">
        <p:scale>
          <a:sx n="62" d="100"/>
          <a:sy n="62" d="100"/>
        </p:scale>
        <p:origin x="105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33AF23-D4DE-49CB-B2E5-F62978D3DD99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2327A9-F6B0-44DA-B57A-0F4CC11BB5D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0814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ndida albicans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s3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s required for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aphylococcus aureus </a:t>
            </a:r>
            <a:r>
              <a:rPr lang="en-GB" sz="1200" b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ycofilm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rmation. Biofilm biomass was removed via sonication, DNA was extracted and the total number of bacterial cells in each biofilm was quantified using qPCR. The total number of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aureus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 of 4 h (A) and 24 h biofilms (B) are presented as colony forming equivalents per mL (CFE/mL). Experiments were repeated three times on three separate occasions.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aureus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FEs dual-species biofilms were compared to that of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aureus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ly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biofilms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*,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 0.05; **,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 0.01).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2327A9-F6B0-44DA-B57A-0F4CC11BB5D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14768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smtClean="0"/>
              <a:t>Supplementary</a:t>
            </a:r>
            <a:r>
              <a:rPr lang="en-GB" baseline="0" dirty="0" smtClean="0"/>
              <a:t> Figure 2. Binding variation of </a:t>
            </a:r>
            <a:r>
              <a:rPr lang="en-GB" i="1" baseline="0" dirty="0" smtClean="0"/>
              <a:t>Staphylococcus aureus </a:t>
            </a:r>
            <a:r>
              <a:rPr lang="en-GB" i="0" baseline="0" dirty="0" smtClean="0"/>
              <a:t>to </a:t>
            </a:r>
            <a:r>
              <a:rPr lang="en-GB" i="1" baseline="0" dirty="0" smtClean="0"/>
              <a:t>Candida albicans </a:t>
            </a:r>
            <a:r>
              <a:rPr lang="en-GB" i="0" baseline="0" dirty="0" smtClean="0"/>
              <a:t>hyphae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C. albicans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ofilms of wild type SC5314,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LS3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d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CE1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eletion mutants were grown for 2 h before adding 5x10</a:t>
            </a:r>
            <a:r>
              <a:rPr lang="en-GB" sz="1200" b="0" kern="1200" baseline="30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7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/mL of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aureus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e-stained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ith hexidium iodide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r a further hour. Calcofluor white was added to the bacterial inoculum to stain the fungal biofilm before washing the biofilm to remove any non-adherent cells before imaging.</a:t>
            </a:r>
            <a:r>
              <a:rPr lang="en-GB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White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rrows point to hyphae with</a:t>
            </a:r>
            <a:r>
              <a:rPr lang="en-GB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losely associated </a:t>
            </a:r>
            <a:r>
              <a:rPr lang="en-GB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. aureus 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s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2327A9-F6B0-44DA-B57A-0F4CC11BB5D0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6867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</a:t>
            </a:r>
            <a:r>
              <a:rPr lang="en-GB" sz="1200" b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3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ndida albicans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ranscriptional changes occur in mature polymicrobial biofilms. Volcano plots shows Log</a:t>
            </a:r>
            <a:r>
              <a:rPr lang="en-GB" sz="1200" b="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fold change versus the negative Log</a:t>
            </a:r>
            <a:r>
              <a:rPr lang="en-GB" sz="1200" b="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the adjusted 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value. Genes of interest can be identified where expression levels are above or below the Log</a:t>
            </a:r>
            <a:r>
              <a:rPr lang="en-GB" sz="1200" b="0" kern="1200" baseline="-250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old change cut-offs of -1.5 and 1.5 (green) and those that are also highly significant (</a:t>
            </a:r>
            <a:r>
              <a:rPr lang="en-GB" sz="1200" b="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 </a:t>
            </a:r>
            <a:r>
              <a:rPr lang="en-GB" sz="1200" b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&lt; 0.01; red). </a:t>
            </a:r>
            <a:endParaRPr lang="en-GB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E460B87-FD78-44C8-BEC3-36C5BBADF300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47679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dirty="0" smtClean="0"/>
              <a:t>Supplementary Figure 4. qPCR</a:t>
            </a:r>
            <a:r>
              <a:rPr lang="en-GB" baseline="0" dirty="0" smtClean="0"/>
              <a:t> validation of RNA-seq. Expression of </a:t>
            </a:r>
            <a:r>
              <a:rPr lang="en-GB" i="1" baseline="0" dirty="0" smtClean="0"/>
              <a:t>C. albicans</a:t>
            </a:r>
            <a:r>
              <a:rPr lang="en-GB" baseline="0" dirty="0" smtClean="0"/>
              <a:t> </a:t>
            </a:r>
            <a:r>
              <a:rPr lang="en-GB" i="1" baseline="0" dirty="0" smtClean="0"/>
              <a:t>ACE2 </a:t>
            </a:r>
            <a:r>
              <a:rPr lang="en-GB" i="0" baseline="0" dirty="0" smtClean="0"/>
              <a:t>(A), </a:t>
            </a:r>
            <a:r>
              <a:rPr lang="en-GB" i="1" baseline="0" dirty="0" smtClean="0"/>
              <a:t>HSP90 </a:t>
            </a:r>
            <a:r>
              <a:rPr lang="en-GB" i="0" baseline="0" dirty="0" smtClean="0"/>
              <a:t>(B) and </a:t>
            </a:r>
            <a:r>
              <a:rPr lang="en-GB" i="1" baseline="0" dirty="0" smtClean="0"/>
              <a:t>MDR1 </a:t>
            </a:r>
            <a:r>
              <a:rPr lang="en-GB" i="0" baseline="0" dirty="0" smtClean="0"/>
              <a:t>(C) were assessed in dual-species </a:t>
            </a:r>
            <a:r>
              <a:rPr lang="en-GB" i="1" baseline="0" dirty="0" smtClean="0"/>
              <a:t>C. albicans </a:t>
            </a:r>
            <a:r>
              <a:rPr lang="en-GB" i="0" baseline="0" dirty="0" smtClean="0"/>
              <a:t>and </a:t>
            </a:r>
            <a:r>
              <a:rPr lang="en-GB" i="1" baseline="0" dirty="0" smtClean="0"/>
              <a:t>S. aureus</a:t>
            </a:r>
            <a:r>
              <a:rPr lang="en-GB" i="0" baseline="0" dirty="0" smtClean="0"/>
              <a:t> biofilms and compared to that of their single species counterparts. Experiments were performed on three separate occasions and data are presented as average values.</a:t>
            </a:r>
            <a:endParaRPr lang="en-GB" b="0" dirty="0" smtClean="0"/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2327A9-F6B0-44DA-B57A-0F4CC11BB5D0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50270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y Figure 5. Increased expression of </a:t>
            </a:r>
            <a:r>
              <a:rPr lang="en-GB" i="1" dirty="0" smtClean="0"/>
              <a:t>PGA4 </a:t>
            </a:r>
            <a:r>
              <a:rPr lang="en-GB" i="0" dirty="0" smtClean="0"/>
              <a:t>in WT biofilms compared to </a:t>
            </a:r>
            <a:r>
              <a:rPr lang="en-GB" sz="1200" b="0" i="1" dirty="0" smtClean="0">
                <a:latin typeface="Arial" panose="020B0604020202020204" pitchFamily="34" charset="0"/>
                <a:cs typeface="Arial" panose="020B0604020202020204" pitchFamily="34" charset="0"/>
              </a:rPr>
              <a:t>ece1</a:t>
            </a:r>
            <a:r>
              <a:rPr lang="en-GB" sz="1200" b="0" dirty="0" smtClean="0">
                <a:latin typeface="Arial" panose="020B0604020202020204" pitchFamily="34" charset="0"/>
                <a:cs typeface="Arial" panose="020B0604020202020204" pitchFamily="34" charset="0"/>
              </a:rPr>
              <a:t>Δ/Δ.</a:t>
            </a:r>
            <a:endParaRPr lang="en-GB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2327A9-F6B0-44DA-B57A-0F4CC11BB5D0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22439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Supplementar</a:t>
            </a:r>
            <a:r>
              <a:rPr lang="en-GB" baseline="0" dirty="0" smtClean="0"/>
              <a:t>y Figure 6. STRING analysis of network of genes linked to </a:t>
            </a:r>
            <a:r>
              <a:rPr lang="en-GB" i="1" baseline="0" dirty="0" smtClean="0"/>
              <a:t>PGA4</a:t>
            </a:r>
            <a:r>
              <a:rPr lang="en-GB" i="1" baseline="0" dirty="0" smtClean="0"/>
              <a:t>. </a:t>
            </a:r>
            <a:r>
              <a:rPr lang="en-GB" i="0" baseline="0" dirty="0" smtClean="0"/>
              <a:t>A gene network created using STRING reveals multiple genes linked </a:t>
            </a:r>
            <a:r>
              <a:rPr lang="en-GB" i="0" baseline="0" smtClean="0"/>
              <a:t>to </a:t>
            </a:r>
            <a:r>
              <a:rPr lang="en-GB" i="1" baseline="0" smtClean="0"/>
              <a:t>PGA4 </a:t>
            </a:r>
            <a:r>
              <a:rPr lang="en-GB" i="0" baseline="0" dirty="0" smtClean="0"/>
              <a:t>(</a:t>
            </a:r>
            <a:r>
              <a:rPr lang="el-GR" i="0" baseline="0" dirty="0" smtClean="0"/>
              <a:t>β</a:t>
            </a:r>
            <a:r>
              <a:rPr lang="en-GB" i="0" baseline="0" dirty="0" smtClean="0"/>
              <a:t>-1,3-glucanosyltransferase; red node). The edges (lines) linking each node represent protein interactions and the greater the number of edges linking each node the more evidence exists suggesting a link. Edges are drawn from curated databases (blue) or from experimental data (pink). Other edges are drawn based on </a:t>
            </a:r>
            <a:r>
              <a:rPr lang="en-GB" i="0" baseline="0" dirty="0" err="1" smtClean="0"/>
              <a:t>textmining</a:t>
            </a:r>
            <a:r>
              <a:rPr lang="en-GB" i="0" baseline="0" dirty="0" smtClean="0"/>
              <a:t>, co-expression and protein homology data (yellow, purple and light blue, respectively).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2327A9-F6B0-44DA-B57A-0F4CC11BB5D0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08336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9976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65196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360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9934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907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20963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7014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9668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368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13991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3643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932F6-9D38-4FD6-86F7-8EA97820D661}" type="datetimeFigureOut">
              <a:rPr lang="en-GB" smtClean="0"/>
              <a:t>26/10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34632-7E9A-4FA8-BE3A-D3AB3A9D616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4939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tiff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4.wdp"/><Relationship Id="rId2" Type="http://schemas.openxmlformats.org/officeDocument/2006/relationships/notesSlide" Target="../notesSlides/notesSlide2.xml"/><Relationship Id="rId16" Type="http://schemas.microsoft.com/office/2007/relationships/hdphoto" Target="../media/hdphoto5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7.png"/><Relationship Id="rId5" Type="http://schemas.openxmlformats.org/officeDocument/2006/relationships/image" Target="../media/image3.tiff"/><Relationship Id="rId15" Type="http://schemas.openxmlformats.org/officeDocument/2006/relationships/image" Target="../media/image10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openxmlformats.org/officeDocument/2006/relationships/image" Target="../media/image9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5" Type="http://schemas.openxmlformats.org/officeDocument/2006/relationships/image" Target="../media/image17.emf"/><Relationship Id="rId4" Type="http://schemas.openxmlformats.org/officeDocument/2006/relationships/oleObject" Target="../embeddings/oleObject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8.emf"/><Relationship Id="rId4" Type="http://schemas.openxmlformats.org/officeDocument/2006/relationships/oleObject" Target="../embeddings/oleObject3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2099348" y="1176972"/>
            <a:ext cx="7805737" cy="4077411"/>
            <a:chOff x="2192338" y="1362952"/>
            <a:chExt cx="7805737" cy="4077411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33690314"/>
                </p:ext>
              </p:extLst>
            </p:nvPr>
          </p:nvGraphicFramePr>
          <p:xfrm>
            <a:off x="2192338" y="1416050"/>
            <a:ext cx="7805737" cy="40243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09" name="Prism 8" r:id="rId4" imgW="7805942" imgH="4025082" progId="Prism8.Document">
                    <p:embed/>
                  </p:oleObj>
                </mc:Choice>
                <mc:Fallback>
                  <p:oleObj name="Prism 8" r:id="rId4" imgW="7805942" imgH="4025082" progId="Prism8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92338" y="1416050"/>
                          <a:ext cx="7805737" cy="40243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2339694" y="1362952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A</a:t>
              </a:r>
              <a:endParaRPr lang="en-GB" b="1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552277" y="1362952"/>
              <a:ext cx="30008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/>
                <a:t>B</a:t>
              </a:r>
              <a:endParaRPr lang="en-GB" b="1" dirty="0"/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414068" y="293298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1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53331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686822" y="652182"/>
            <a:ext cx="728084" cy="369332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GB" dirty="0" smtClean="0"/>
              <a:t>Fig S2</a:t>
            </a:r>
            <a:endParaRPr lang="en-GB" dirty="0"/>
          </a:p>
        </p:txBody>
      </p:sp>
      <p:grpSp>
        <p:nvGrpSpPr>
          <p:cNvPr id="6" name="Group 5"/>
          <p:cNvGrpSpPr/>
          <p:nvPr/>
        </p:nvGrpSpPr>
        <p:grpSpPr>
          <a:xfrm>
            <a:off x="4599708" y="333808"/>
            <a:ext cx="2160000" cy="2160000"/>
            <a:chOff x="1787237" y="754008"/>
            <a:chExt cx="9476508" cy="7107381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87237" y="754008"/>
              <a:ext cx="9476508" cy="7107381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5" name="Straight Arrow Connector 4"/>
            <p:cNvCxnSpPr/>
            <p:nvPr/>
          </p:nvCxnSpPr>
          <p:spPr>
            <a:xfrm flipV="1">
              <a:off x="4718117" y="4100949"/>
              <a:ext cx="1086939" cy="1026462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2052256" y="333808"/>
            <a:ext cx="2160000" cy="2160000"/>
            <a:chOff x="1524000" y="0"/>
            <a:chExt cx="9144000" cy="6858000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10" name="Straight Arrow Connector 9"/>
            <p:cNvCxnSpPr/>
            <p:nvPr/>
          </p:nvCxnSpPr>
          <p:spPr>
            <a:xfrm flipV="1">
              <a:off x="6096000" y="3477492"/>
              <a:ext cx="498763" cy="1078662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Group 15"/>
          <p:cNvGrpSpPr/>
          <p:nvPr/>
        </p:nvGrpSpPr>
        <p:grpSpPr>
          <a:xfrm>
            <a:off x="7147160" y="333808"/>
            <a:ext cx="2160000" cy="2160000"/>
            <a:chOff x="1524000" y="0"/>
            <a:chExt cx="9144000" cy="6858000"/>
          </a:xfrm>
        </p:grpSpPr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15" name="Straight Arrow Connector 14"/>
            <p:cNvCxnSpPr/>
            <p:nvPr/>
          </p:nvCxnSpPr>
          <p:spPr>
            <a:xfrm>
              <a:off x="5001491" y="2355273"/>
              <a:ext cx="665018" cy="9144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" name="Group 20"/>
          <p:cNvGrpSpPr/>
          <p:nvPr/>
        </p:nvGrpSpPr>
        <p:grpSpPr>
          <a:xfrm>
            <a:off x="2052256" y="2606742"/>
            <a:ext cx="2160000" cy="2160000"/>
            <a:chOff x="1524000" y="0"/>
            <a:chExt cx="9144000" cy="6858000"/>
          </a:xfrm>
        </p:grpSpPr>
        <p:pic>
          <p:nvPicPr>
            <p:cNvPr id="17" name="Picture 16"/>
            <p:cNvPicPr>
              <a:picLocks noChangeAspect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19" name="Straight Arrow Connector 18"/>
            <p:cNvCxnSpPr/>
            <p:nvPr/>
          </p:nvCxnSpPr>
          <p:spPr>
            <a:xfrm flipV="1">
              <a:off x="2632364" y="3172692"/>
              <a:ext cx="235527" cy="1052943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Group 24"/>
          <p:cNvGrpSpPr/>
          <p:nvPr/>
        </p:nvGrpSpPr>
        <p:grpSpPr>
          <a:xfrm>
            <a:off x="4599708" y="2606742"/>
            <a:ext cx="2160000" cy="2160000"/>
            <a:chOff x="1524000" y="0"/>
            <a:chExt cx="9144000" cy="6858000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25000"/>
                      </a14:imgEffect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24" name="Straight Arrow Connector 23"/>
            <p:cNvCxnSpPr/>
            <p:nvPr/>
          </p:nvCxnSpPr>
          <p:spPr>
            <a:xfrm flipV="1">
              <a:off x="4114800" y="3255818"/>
              <a:ext cx="1310191" cy="69273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/>
          <p:cNvGrpSpPr/>
          <p:nvPr/>
        </p:nvGrpSpPr>
        <p:grpSpPr>
          <a:xfrm>
            <a:off x="7148943" y="2606742"/>
            <a:ext cx="2160000" cy="2160000"/>
            <a:chOff x="1524000" y="0"/>
            <a:chExt cx="9144000" cy="6858000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28" name="Straight Arrow Connector 27"/>
            <p:cNvCxnSpPr/>
            <p:nvPr/>
          </p:nvCxnSpPr>
          <p:spPr>
            <a:xfrm flipH="1" flipV="1">
              <a:off x="5267750" y="2385168"/>
              <a:ext cx="1393253" cy="734301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9" name="Group 38"/>
          <p:cNvGrpSpPr/>
          <p:nvPr/>
        </p:nvGrpSpPr>
        <p:grpSpPr>
          <a:xfrm>
            <a:off x="2052256" y="4879676"/>
            <a:ext cx="2160000" cy="2160000"/>
            <a:chOff x="1524000" y="0"/>
            <a:chExt cx="9144000" cy="6858000"/>
          </a:xfrm>
        </p:grpSpPr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36" name="Straight Arrow Connector 35"/>
            <p:cNvCxnSpPr/>
            <p:nvPr/>
          </p:nvCxnSpPr>
          <p:spPr>
            <a:xfrm flipV="1">
              <a:off x="2632363" y="1662928"/>
              <a:ext cx="332507" cy="1151198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Arrow Connector 37"/>
            <p:cNvCxnSpPr/>
            <p:nvPr/>
          </p:nvCxnSpPr>
          <p:spPr>
            <a:xfrm flipH="1">
              <a:off x="4580890" y="3429000"/>
              <a:ext cx="923823" cy="907472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5" name="Group 44"/>
          <p:cNvGrpSpPr/>
          <p:nvPr/>
        </p:nvGrpSpPr>
        <p:grpSpPr>
          <a:xfrm>
            <a:off x="4599708" y="4879676"/>
            <a:ext cx="2160000" cy="2160000"/>
            <a:chOff x="1524000" y="0"/>
            <a:chExt cx="9144000" cy="6858000"/>
          </a:xfrm>
        </p:grpSpPr>
        <p:pic>
          <p:nvPicPr>
            <p:cNvPr id="42" name="Picture 41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44" name="Straight Arrow Connector 43"/>
            <p:cNvCxnSpPr/>
            <p:nvPr/>
          </p:nvCxnSpPr>
          <p:spPr>
            <a:xfrm flipV="1">
              <a:off x="6096000" y="4502728"/>
              <a:ext cx="1427014" cy="777062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/>
          <p:cNvGrpSpPr/>
          <p:nvPr/>
        </p:nvGrpSpPr>
        <p:grpSpPr>
          <a:xfrm>
            <a:off x="7147160" y="4879676"/>
            <a:ext cx="2160000" cy="2160000"/>
            <a:chOff x="1524000" y="0"/>
            <a:chExt cx="9144000" cy="6858000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0"/>
              <a:ext cx="9144000" cy="6858000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cxnSp>
          <p:nvCxnSpPr>
            <p:cNvPr id="49" name="Straight Arrow Connector 48"/>
            <p:cNvCxnSpPr/>
            <p:nvPr/>
          </p:nvCxnSpPr>
          <p:spPr>
            <a:xfrm flipV="1">
              <a:off x="4480034" y="2244436"/>
              <a:ext cx="944957" cy="435657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3" name="TextBox 52"/>
          <p:cNvSpPr txBox="1"/>
          <p:nvPr/>
        </p:nvSpPr>
        <p:spPr>
          <a:xfrm rot="16200000">
            <a:off x="1142819" y="1197025"/>
            <a:ext cx="923651" cy="33855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5314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1141557" y="3519879"/>
            <a:ext cx="936475" cy="33855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GB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ls3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Δ/Δ</a:t>
            </a:r>
            <a:endParaRPr lang="en-GB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1108354" y="5849184"/>
            <a:ext cx="992579" cy="338554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GB" sz="16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ece1</a:t>
            </a:r>
            <a:r>
              <a:rPr lang="en-GB" sz="1600" b="1" dirty="0">
                <a:latin typeface="Arial" panose="020B0604020202020204" pitchFamily="34" charset="0"/>
                <a:cs typeface="Arial" panose="020B0604020202020204" pitchFamily="34" charset="0"/>
              </a:rPr>
              <a:t>Δ/Δ</a:t>
            </a:r>
            <a:endParaRPr lang="en-GB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55"/>
          <p:cNvCxnSpPr/>
          <p:nvPr/>
        </p:nvCxnSpPr>
        <p:spPr>
          <a:xfrm>
            <a:off x="1885584" y="758879"/>
            <a:ext cx="0" cy="121484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1885583" y="5352253"/>
            <a:ext cx="0" cy="121484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1885583" y="3081732"/>
            <a:ext cx="0" cy="1214846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825083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3042499" y="27157"/>
            <a:ext cx="7521727" cy="7737759"/>
            <a:chOff x="3042499" y="27157"/>
            <a:chExt cx="7521727" cy="773775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/>
            <a:srcRect l="19220" t="33098" r="37283" b="14795"/>
            <a:stretch/>
          </p:blipFill>
          <p:spPr>
            <a:xfrm>
              <a:off x="3616448" y="462473"/>
              <a:ext cx="3297190" cy="2348678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4"/>
            <a:srcRect l="19150" t="33953" r="37544" b="14822"/>
            <a:stretch/>
          </p:blipFill>
          <p:spPr>
            <a:xfrm>
              <a:off x="3616448" y="2878341"/>
              <a:ext cx="3294444" cy="234867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/>
            <a:srcRect l="19303" t="35356" r="37033" b="9971"/>
            <a:stretch/>
          </p:blipFill>
          <p:spPr>
            <a:xfrm>
              <a:off x="3616448" y="5227019"/>
              <a:ext cx="3316871" cy="2537897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6"/>
            <a:srcRect l="25902" t="27946" r="26166" b="17293"/>
            <a:stretch/>
          </p:blipFill>
          <p:spPr>
            <a:xfrm>
              <a:off x="7136964" y="574765"/>
              <a:ext cx="3416050" cy="2236385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7"/>
            <a:srcRect l="26038" t="29911" r="25972" b="12669"/>
            <a:stretch/>
          </p:blipFill>
          <p:spPr>
            <a:xfrm>
              <a:off x="7136965" y="2811151"/>
              <a:ext cx="3416050" cy="2415868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8"/>
            <a:srcRect l="25737" t="31430" r="25972" b="7946"/>
            <a:stretch/>
          </p:blipFill>
          <p:spPr>
            <a:xfrm>
              <a:off x="7125751" y="5227019"/>
              <a:ext cx="3438475" cy="2470707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 rot="16200000">
              <a:off x="2749950" y="1467535"/>
              <a:ext cx="92365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5314</a:t>
              </a:r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748687" y="3849809"/>
              <a:ext cx="93647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s3</a:t>
              </a:r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Δ/Δ</a:t>
              </a:r>
              <a:endParaRPr lang="en-GB" sz="16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2715486" y="6161171"/>
              <a:ext cx="9925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ece1</a:t>
              </a:r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Δ/Δ</a:t>
              </a:r>
              <a:endParaRPr lang="en-GB" sz="16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075149" y="27157"/>
              <a:ext cx="48122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 h</a:t>
              </a:r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594758" y="27157"/>
              <a:ext cx="59503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 h</a:t>
              </a:r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Straight Connector 23"/>
            <p:cNvCxnSpPr/>
            <p:nvPr/>
          </p:nvCxnSpPr>
          <p:spPr>
            <a:xfrm>
              <a:off x="3492715" y="1029389"/>
              <a:ext cx="0" cy="1214846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/>
          </p:nvCxnSpPr>
          <p:spPr>
            <a:xfrm>
              <a:off x="3492715" y="5664240"/>
              <a:ext cx="0" cy="1214846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/>
          </p:nvCxnSpPr>
          <p:spPr>
            <a:xfrm>
              <a:off x="3492715" y="3411662"/>
              <a:ext cx="0" cy="1214846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/>
          </p:nvCxnSpPr>
          <p:spPr>
            <a:xfrm flipH="1">
              <a:off x="8222468" y="434573"/>
              <a:ext cx="1245039" cy="791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>
              <a:off x="4678073" y="430217"/>
              <a:ext cx="1245039" cy="7910"/>
            </a:xfrm>
            <a:prstGeom prst="line">
              <a:avLst/>
            </a:prstGeom>
            <a:ln w="381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" name="TextBox 2"/>
          <p:cNvSpPr txBox="1"/>
          <p:nvPr/>
        </p:nvSpPr>
        <p:spPr>
          <a:xfrm>
            <a:off x="534838" y="574765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38736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8944006"/>
              </p:ext>
            </p:extLst>
          </p:nvPr>
        </p:nvGraphicFramePr>
        <p:xfrm>
          <a:off x="1514248" y="1091554"/>
          <a:ext cx="8869617" cy="4960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7" name="Prism 8" r:id="rId4" imgW="6580040" imgH="3680414" progId="Prism8.Document">
                  <p:embed/>
                </p:oleObj>
              </mc:Choice>
              <mc:Fallback>
                <p:oleObj name="Prism 8" r:id="rId4" imgW="6580040" imgH="36804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514248" y="1091554"/>
                        <a:ext cx="8869617" cy="4960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514248" y="176848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A</a:t>
            </a:r>
            <a:endParaRPr lang="en-GB" sz="16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4334916" y="1768487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774983" y="1801164"/>
            <a:ext cx="2936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/>
              <a:t>C</a:t>
            </a:r>
            <a:endParaRPr lang="en-GB" sz="1600" b="1" dirty="0"/>
          </a:p>
        </p:txBody>
      </p:sp>
    </p:spTree>
    <p:extLst>
      <p:ext uri="{BB962C8B-B14F-4D97-AF65-F5344CB8AC3E}">
        <p14:creationId xmlns:p14="http://schemas.microsoft.com/office/powerpoint/2010/main" val="28439884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883403" y="666427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4</a:t>
            </a:r>
            <a:endParaRPr lang="en-GB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2611193"/>
              </p:ext>
            </p:extLst>
          </p:nvPr>
        </p:nvGraphicFramePr>
        <p:xfrm>
          <a:off x="3692121" y="1221738"/>
          <a:ext cx="4026035" cy="42048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6" name="Prism 8" r:id="rId4" imgW="2358529" imgH="2463814" progId="Prism8.Document">
                  <p:embed/>
                </p:oleObj>
              </mc:Choice>
              <mc:Fallback>
                <p:oleObj name="Prism 8" r:id="rId4" imgW="2358529" imgH="246381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92121" y="1221738"/>
                        <a:ext cx="4026035" cy="42048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3269616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71" r="16558"/>
          <a:stretch/>
        </p:blipFill>
        <p:spPr>
          <a:xfrm>
            <a:off x="2054851" y="0"/>
            <a:ext cx="8171500" cy="677464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3853" y="242596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 S5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72560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DF89DF146FD0341AF8D36DB073329EC" ma:contentTypeVersion="9" ma:contentTypeDescription="Create a new document." ma:contentTypeScope="" ma:versionID="018f2ee5b79d8eca120328ebbc906660">
  <xsd:schema xmlns:xsd="http://www.w3.org/2001/XMLSchema" xmlns:xs="http://www.w3.org/2001/XMLSchema" xmlns:p="http://schemas.microsoft.com/office/2006/metadata/properties" xmlns:ns3="bb565058-b3a3-4a9d-93f9-fc91e44b5b5d" targetNamespace="http://schemas.microsoft.com/office/2006/metadata/properties" ma:root="true" ma:fieldsID="49b3abfb37666fd0a187ba78983516c8" ns3:_="">
    <xsd:import namespace="bb565058-b3a3-4a9d-93f9-fc91e44b5b5d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b565058-b3a3-4a9d-93f9-fc91e44b5b5d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1A6EB10A-2414-46D1-B0AC-2CE83F73ACD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b565058-b3a3-4a9d-93f9-fc91e44b5b5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47A7124-8FA8-4136-8905-AD599E474227}">
  <ds:schemaRefs>
    <ds:schemaRef ds:uri="http://purl.org/dc/dcmitype/"/>
    <ds:schemaRef ds:uri="bb565058-b3a3-4a9d-93f9-fc91e44b5b5d"/>
    <ds:schemaRef ds:uri="http://schemas.microsoft.com/office/2006/documentManagement/types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schemas.microsoft.com/office/infopath/2007/PartnerControls"/>
    <ds:schemaRef ds:uri="http://www.w3.org/XML/1998/namespace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14A9F41D-2D03-476C-932C-C232AC8C283E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621</TotalTime>
  <Words>476</Words>
  <Application>Microsoft Office PowerPoint</Application>
  <PresentationFormat>Widescreen</PresentationFormat>
  <Paragraphs>30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The West Of Scotlan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yn Short</dc:creator>
  <cp:lastModifiedBy>Bryn Short</cp:lastModifiedBy>
  <cp:revision>37</cp:revision>
  <dcterms:created xsi:type="dcterms:W3CDTF">2020-12-08T12:34:20Z</dcterms:created>
  <dcterms:modified xsi:type="dcterms:W3CDTF">2021-10-26T08:1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DF89DF146FD0341AF8D36DB073329EC</vt:lpwstr>
  </property>
</Properties>
</file>